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7432000" cy="2057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07DCE-FA17-4EC3-95CE-5DC67B0490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2468880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371600" y="11892600"/>
            <a:ext cx="2468880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587A6-5452-47D3-8F32-4679934686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02236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600" y="11892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022360" y="11892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09B94-78D5-44F2-B0E5-B9A4516A60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9718920" y="4800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066240" y="4800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371600" y="11892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9718920" y="11892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066240" y="11892600"/>
            <a:ext cx="79495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21CDB-FC84-4F3B-8705-B91E42961E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371600" y="4800600"/>
            <a:ext cx="24688800" cy="13577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401"/>
              </a:spcBef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B0AB8-55D9-4B1F-9E3F-0CB24520D3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2468880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4D960-C505-47EF-B42C-9C22972CDD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1204812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022360" y="4800600"/>
            <a:ext cx="1204812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1D21C-C7E7-42F9-8153-298AA86461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3CF7B-49DA-4630-8346-00016C6F31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371600" y="823680"/>
            <a:ext cx="24688800" cy="15896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401"/>
              </a:spcBef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D74BE-8D5F-4FA4-BB21-2D317F5D48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022360" y="4800600"/>
            <a:ext cx="1204812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371600" y="11892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2B8CF-5F16-45B7-A3DC-717953E547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1204812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02236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022360" y="11892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D31E4-3DFF-41F3-A1CA-07CC6A7FC2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37160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022360" y="4800600"/>
            <a:ext cx="1204812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371600" y="11892600"/>
            <a:ext cx="24688800" cy="64764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indent="0">
              <a:spcBef>
                <a:spcPts val="2401"/>
              </a:spcBef>
              <a:buNone/>
              <a:tabLst>
                <a:tab algn="l" pos="2743200"/>
                <a:tab algn="l" pos="5486400"/>
                <a:tab algn="l" pos="8229600"/>
              </a:tabLst>
            </a:pP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137B7-5287-4830-B9AD-91B323DA7F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371600" y="823680"/>
            <a:ext cx="24688800" cy="342900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ctr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r>
              <a:rPr b="0" lang="en-US" sz="13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371600" y="4800600"/>
            <a:ext cx="24688800" cy="1357776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rmAutofit/>
          </a:bodyPr>
          <a:p>
            <a:pPr marL="1028880" indent="-1028880">
              <a:spcBef>
                <a:spcPts val="2401"/>
              </a:spcBef>
              <a:buClr>
                <a:srgbClr val="000000"/>
              </a:buClr>
              <a:buFont typeface="Arial"/>
              <a:buChar char="•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1" marL="2228760" indent="-857160">
              <a:spcBef>
                <a:spcPts val="2401"/>
              </a:spcBef>
              <a:buClr>
                <a:srgbClr val="000000"/>
              </a:buClr>
              <a:buFont typeface="Arial"/>
              <a:buChar char="–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2" marL="3429000" indent="-685800">
              <a:spcBef>
                <a:spcPts val="2401"/>
              </a:spcBef>
              <a:buClr>
                <a:srgbClr val="000000"/>
              </a:buClr>
              <a:buFont typeface="Arial"/>
              <a:buChar char="•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3" marL="4800600" indent="-685800">
              <a:spcBef>
                <a:spcPts val="2401"/>
              </a:spcBef>
              <a:buClr>
                <a:srgbClr val="000000"/>
              </a:buClr>
              <a:buFont typeface="Arial"/>
              <a:buChar char="–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4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5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  <a:p>
            <a:pPr lvl="6" marL="6172200" indent="-685800">
              <a:spcBef>
                <a:spcPts val="2401"/>
              </a:spcBef>
              <a:buClr>
                <a:srgbClr val="000000"/>
              </a:buClr>
              <a:buFont typeface="Arial"/>
              <a:buChar char="»"/>
              <a:tabLst>
                <a:tab algn="l" pos="2743200"/>
                <a:tab algn="l" pos="5486400"/>
                <a:tab algn="l" pos="8229600"/>
              </a:tabLst>
            </a:pPr>
            <a:r>
              <a:rPr b="0" lang="en-US" sz="9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371600" y="18735840"/>
            <a:ext cx="6400800" cy="14284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Autofit/>
          </a:bodyPr>
          <a:lstStyle>
            <a:lvl1pPr indent="0">
              <a:buNone/>
              <a:tabLst>
                <a:tab algn="l" pos="0"/>
                <a:tab algn="l" pos="2743200"/>
                <a:tab algn="l" pos="5486400"/>
                <a:tab algn="l" pos="822960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372600" y="18735840"/>
            <a:ext cx="8686800" cy="14284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Autofit/>
          </a:bodyPr>
          <a:lstStyle>
            <a:lvl1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9659600" y="18735840"/>
            <a:ext cx="6400800" cy="1428480"/>
          </a:xfrm>
          <a:prstGeom prst="rect">
            <a:avLst/>
          </a:prstGeom>
          <a:noFill/>
          <a:ln w="0">
            <a:noFill/>
          </a:ln>
        </p:spPr>
        <p:txBody>
          <a:bodyPr lIns="274320" rIns="274320" tIns="137160" bIns="137160" anchor="t">
            <a:noAutofit/>
          </a:bodyPr>
          <a:lstStyle>
            <a:lvl1pPr indent="0" algn="r">
              <a:buNone/>
              <a:tabLst>
                <a:tab algn="l" pos="0"/>
                <a:tab algn="l" pos="2743200"/>
                <a:tab algn="l" pos="5486400"/>
                <a:tab algn="l" pos="8229600"/>
              </a:tabLst>
              <a:defRPr b="0" lang="en-US" sz="4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fld id="{1406E375-F0A7-4556-BE6C-D9AFC4E4D74E}" type="slidenum">
              <a:rPr b="0" lang="en-US" sz="4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371600" y="457200"/>
            <a:ext cx="24688800" cy="1646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2743200"/>
                <a:tab algn="l" pos="5486400"/>
                <a:tab algn="l" pos="8229600"/>
              </a:tabLst>
            </a:pPr>
            <a:r>
              <a:rPr b="1" lang="en-US" sz="5400" spc="-1" strike="noStrike">
                <a:solidFill>
                  <a:srgbClr val="000000"/>
                </a:solidFill>
                <a:latin typeface="Arial"/>
              </a:rPr>
              <a:t>Scheme of  procedures for  </a:t>
            </a:r>
            <a:r>
              <a:rPr b="1" i="1" lang="en-US" sz="5400" spc="-1" strike="noStrike">
                <a:solidFill>
                  <a:srgbClr val="000000"/>
                </a:solidFill>
                <a:latin typeface="Arial"/>
              </a:rPr>
              <a:t>C. elegans</a:t>
            </a:r>
            <a:r>
              <a:rPr b="1" lang="en-US" sz="5400" spc="-1" strike="noStrike">
                <a:solidFill>
                  <a:srgbClr val="000000"/>
                </a:solidFill>
                <a:latin typeface="Arial"/>
              </a:rPr>
              <a:t> transgene construction by </a:t>
            </a:r>
            <a:br>
              <a:rPr sz="5400"/>
            </a:br>
            <a:r>
              <a:rPr b="1" lang="en-US" sz="5400" spc="-1" strike="noStrike">
                <a:solidFill>
                  <a:srgbClr val="000000"/>
                </a:solidFill>
                <a:latin typeface="Arial"/>
              </a:rPr>
              <a:t>fosmid DNA recombineering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4706720" y="2590920"/>
            <a:ext cx="11887200" cy="74451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1066680" y="2590920"/>
            <a:ext cx="12192120" cy="76690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14478120" y="11069640"/>
            <a:ext cx="12115800" cy="85215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1066680" y="11280600"/>
            <a:ext cx="11734920" cy="831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4T03:15:31Z</dcterms:created>
  <dc:creator>fishera</dc:creator>
  <dc:description/>
  <dc:language>en-US</dc:language>
  <cp:lastModifiedBy>FisherA</cp:lastModifiedBy>
  <dcterms:modified xsi:type="dcterms:W3CDTF">2008-10-13T21:11:10Z</dcterms:modified>
  <cp:revision>8</cp:revision>
  <dc:subject/>
  <dc:title>Scheme of  procedures of  C.elegans tansgene construction by  fosmid DNA recombineering</dc:title>
</cp:coreProperties>
</file>